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B7F74-30A6-4B91-B652-71EDC10926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3CDFB-37E7-4E2C-8AA5-5131EBF38C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6AA0D-581C-4E00-9F2D-519AE1B6EB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58373-4F62-4BAD-854B-0770FBBAE4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31038-2674-4EFA-B156-A06112A548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81AAD-ECBD-4ABF-A264-27F65DB3A3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F3C50-9A55-4D80-B225-26C76B2834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45A6B-9329-4338-9E03-7EC4EC2383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EC68A-BA0A-411D-82AD-F28F210F44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2178F-E66B-42DD-A505-6AF652920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225E3-9097-4AE6-948A-E04609EBFB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8622C-3E47-4D6F-9415-2E2FD5A186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8E004C-8785-4F02-A85C-753ACA9939F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4"/>
          <p:cNvGrpSpPr/>
          <p:nvPr/>
        </p:nvGrpSpPr>
        <p:grpSpPr>
          <a:xfrm>
            <a:off x="177840" y="284040"/>
            <a:ext cx="6367320" cy="5038920"/>
            <a:chOff x="177840" y="284040"/>
            <a:chExt cx="6367320" cy="5038920"/>
          </a:xfrm>
        </p:grpSpPr>
        <p:pic>
          <p:nvPicPr>
            <p:cNvPr id="42" name="Picture 6" descr="E:\A张晓梅博士期间文件\中山医学院王海河教授\ZXM实验\石宏顺实验\卵巢癌IHC-PCBP1\20170410\1971N.tif"/>
            <p:cNvPicPr/>
            <p:nvPr/>
          </p:nvPicPr>
          <p:blipFill>
            <a:blip r:embed="rId1"/>
            <a:stretch/>
          </p:blipFill>
          <p:spPr>
            <a:xfrm>
              <a:off x="456120" y="4654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7" descr="E:\A张晓梅博士期间文件\中山医学院王海河教授\ZXM实验\石宏顺实验\卵巢癌IHC-PCBP1\20170410\1924N.tif"/>
            <p:cNvPicPr/>
            <p:nvPr/>
          </p:nvPicPr>
          <p:blipFill>
            <a:blip r:embed="rId2"/>
            <a:stretch/>
          </p:blipFill>
          <p:spPr>
            <a:xfrm>
              <a:off x="1964880" y="4654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" descr="E:\A张晓梅博士期间文件\中山医学院王海河教授\ZXM实验\石宏顺实验\卵巢癌IHC-PCBP1\20170410\2026N.tif"/>
            <p:cNvPicPr/>
            <p:nvPr/>
          </p:nvPicPr>
          <p:blipFill>
            <a:blip r:embed="rId3"/>
            <a:stretch/>
          </p:blipFill>
          <p:spPr>
            <a:xfrm>
              <a:off x="3469680" y="4654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9" descr="E:\A张晓梅博士期间文件\中山医学院王海河教授\ZXM实验\石宏顺实验\卵巢癌IHC-PCBP1\20170410\2033N.tif"/>
            <p:cNvPicPr/>
            <p:nvPr/>
          </p:nvPicPr>
          <p:blipFill>
            <a:blip r:embed="rId4"/>
            <a:stretch/>
          </p:blipFill>
          <p:spPr>
            <a:xfrm>
              <a:off x="4985280" y="4654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12" descr="E:\A张晓梅博士期间文件\中山医学院王海河教授\ZXM实验\石宏顺实验\卵巢癌IHC-PCBP1\20170410\1939T.tif"/>
            <p:cNvPicPr/>
            <p:nvPr/>
          </p:nvPicPr>
          <p:blipFill>
            <a:blip r:embed="rId5"/>
            <a:stretch/>
          </p:blipFill>
          <p:spPr>
            <a:xfrm>
              <a:off x="1975680" y="294156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4" descr="E:\A张晓梅博士期间文件\中山医学院王海河教授\ZXM实验\石宏顺实验\卵巢癌IHC-PCBP1\20170410\1805T.tif"/>
            <p:cNvPicPr/>
            <p:nvPr/>
          </p:nvPicPr>
          <p:blipFill>
            <a:blip r:embed="rId6"/>
            <a:stretch/>
          </p:blipFill>
          <p:spPr>
            <a:xfrm>
              <a:off x="3492720" y="293904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15" descr="E:\A张晓梅博士期间文件\中山医学院王海河教授\ZXM实验\石宏顺实验\卵巢癌IHC-PCBP1\20170410\2141T-1.tif"/>
            <p:cNvPicPr/>
            <p:nvPr/>
          </p:nvPicPr>
          <p:blipFill>
            <a:blip r:embed="rId7"/>
            <a:stretch/>
          </p:blipFill>
          <p:spPr>
            <a:xfrm>
              <a:off x="5002920" y="293724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7" descr="E:\A张晓梅博士期间文件\中山医学院王海河教授\ZXM实验\石宏顺实验\卵巢癌IHC-P27\20170410\1918N.tif"/>
            <p:cNvPicPr/>
            <p:nvPr/>
          </p:nvPicPr>
          <p:blipFill>
            <a:blip r:embed="rId8"/>
            <a:stretch/>
          </p:blipFill>
          <p:spPr>
            <a:xfrm>
              <a:off x="452880" y="160740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8" descr="E:\A张晓梅博士期间文件\中山医学院王海河教授\ZXM实验\石宏顺实验\卵巢癌IHC-P27\20170410\2013N.tif"/>
            <p:cNvPicPr/>
            <p:nvPr/>
          </p:nvPicPr>
          <p:blipFill>
            <a:blip r:embed="rId9"/>
            <a:stretch/>
          </p:blipFill>
          <p:spPr>
            <a:xfrm>
              <a:off x="1969920" y="160560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9" descr="E:\A张晓梅博士期间文件\中山医学院王海河教授\ZXM实验\石宏顺实验\卵巢癌IHC-P27\20170410\1847N.tif"/>
            <p:cNvPicPr/>
            <p:nvPr/>
          </p:nvPicPr>
          <p:blipFill>
            <a:blip r:embed="rId10"/>
            <a:stretch/>
          </p:blipFill>
          <p:spPr>
            <a:xfrm>
              <a:off x="3482640" y="160740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20" descr="E:\A张晓梅博士期间文件\中山医学院王海河教授\ZXM实验\石宏顺实验\卵巢癌IHC-P27\20170410\2033N.tif"/>
            <p:cNvPicPr/>
            <p:nvPr/>
          </p:nvPicPr>
          <p:blipFill>
            <a:blip r:embed="rId11"/>
            <a:stretch/>
          </p:blipFill>
          <p:spPr>
            <a:xfrm>
              <a:off x="4991760" y="16030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21" descr="E:\A张晓梅博士期间文件\中山医学院王海河教授\ZXM实验\石宏顺实验\卵巢癌IHC-P27\20170410\1991T.tif"/>
            <p:cNvPicPr/>
            <p:nvPr/>
          </p:nvPicPr>
          <p:blipFill>
            <a:blip r:embed="rId12"/>
            <a:stretch/>
          </p:blipFill>
          <p:spPr>
            <a:xfrm>
              <a:off x="1975680" y="40744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23" descr="E:\A张晓梅博士期间文件\中山医学院王海河教授\ZXM实验\石宏顺实验\卵巢癌IHC-P27\20170410\2141T.tif"/>
            <p:cNvPicPr/>
            <p:nvPr/>
          </p:nvPicPr>
          <p:blipFill>
            <a:blip r:embed="rId13"/>
            <a:stretch/>
          </p:blipFill>
          <p:spPr>
            <a:xfrm>
              <a:off x="5002920" y="407196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24" descr="E:\A张晓梅博士期间文件\中山医学院王海河教授\ZXM实验\石宏顺实验\卵巢癌IHC-P27\20170410\1691T-1.tif"/>
            <p:cNvPicPr/>
            <p:nvPr/>
          </p:nvPicPr>
          <p:blipFill>
            <a:blip r:embed="rId14"/>
            <a:stretch/>
          </p:blipFill>
          <p:spPr>
            <a:xfrm>
              <a:off x="3492720" y="4074480"/>
              <a:ext cx="1478880" cy="1109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17"/>
            <p:cNvSpPr/>
            <p:nvPr/>
          </p:nvSpPr>
          <p:spPr>
            <a:xfrm>
              <a:off x="1610280" y="1312920"/>
              <a:ext cx="493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                                 3                                2                                 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TextBox 18"/>
            <p:cNvSpPr/>
            <p:nvPr/>
          </p:nvSpPr>
          <p:spPr>
            <a:xfrm>
              <a:off x="1670400" y="2431440"/>
              <a:ext cx="4833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                                2                                1                               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TextBox 25"/>
            <p:cNvSpPr/>
            <p:nvPr/>
          </p:nvSpPr>
          <p:spPr>
            <a:xfrm rot="16200000">
              <a:off x="-372960" y="847080"/>
              <a:ext cx="137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BP1 Normal ovar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TextBox 38"/>
            <p:cNvSpPr/>
            <p:nvPr/>
          </p:nvSpPr>
          <p:spPr>
            <a:xfrm rot="16200000">
              <a:off x="-384840" y="1947960"/>
              <a:ext cx="137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27 Normal ovar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Box 39"/>
            <p:cNvSpPr/>
            <p:nvPr/>
          </p:nvSpPr>
          <p:spPr>
            <a:xfrm>
              <a:off x="3144600" y="3760200"/>
              <a:ext cx="333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                                1                               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TextBox 40"/>
            <p:cNvSpPr/>
            <p:nvPr/>
          </p:nvSpPr>
          <p:spPr>
            <a:xfrm rot="16200000">
              <a:off x="1133640" y="3388680"/>
              <a:ext cx="137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BP1 Ovary cance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TextBox 42"/>
            <p:cNvSpPr/>
            <p:nvPr/>
          </p:nvSpPr>
          <p:spPr>
            <a:xfrm rot="16200000">
              <a:off x="1123920" y="4513680"/>
              <a:ext cx="137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27 Ovary cance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TextBox 43"/>
            <p:cNvSpPr/>
            <p:nvPr/>
          </p:nvSpPr>
          <p:spPr>
            <a:xfrm>
              <a:off x="3158280" y="4887000"/>
              <a:ext cx="333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                                1                               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4" name="Text Box 15"/>
          <p:cNvSpPr/>
          <p:nvPr/>
        </p:nvSpPr>
        <p:spPr>
          <a:xfrm>
            <a:off x="468360" y="5761080"/>
            <a:ext cx="63309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7 Expression of PCBP1 and p27 in ovary cancer samples compared to that in the normal tissu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indicated protein expression level was defined based on the staining intensity  under the same robust  IHC staining condit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15:54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